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66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3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4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" descr="陈家靖 组化 睾丸-2 GLOD4_10.0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459480" y="2075180"/>
            <a:ext cx="5273040" cy="270764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682750" y="365125"/>
            <a:ext cx="833818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 Immunohistochemical staining of GLOD4 protein in testes of 12-month Qianbei Ma goat. (a) Immunostaining pattern of GLOD4 protein in 12M testes (100×) of Qianbei Ma goat. (b) Immunostaining pattern of GLOD4 protein in 12M testes (400×) of QianbeiMa goat;</a:t>
            </a:r>
            <a:endParaRPr lang="zh-CN" altLang="en-US"/>
          </a:p>
        </p:txBody>
      </p: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2" descr="陈家靖 组化 睾丸-2 GLOD4_40.0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91790" y="1060450"/>
            <a:ext cx="5273040" cy="270764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3" descr="陈家靖 组化睾丸-2 阴对_20.0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459480" y="2075180"/>
            <a:ext cx="5273040" cy="270764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commondata" val="eyJoZGlkIjoiNjQ5NjlkZjQ4NmY2YmRlZWY0ZDc5MDc2N2QzMGZhMDQ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4</Words>
  <Application>WPS 演示</Application>
  <PresentationFormat>宽屏</PresentationFormat>
  <Paragraphs>2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格林</cp:lastModifiedBy>
  <cp:revision>156</cp:revision>
  <dcterms:created xsi:type="dcterms:W3CDTF">2019-06-19T02:08:00Z</dcterms:created>
  <dcterms:modified xsi:type="dcterms:W3CDTF">2024-03-05T12:25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388</vt:lpwstr>
  </property>
  <property fmtid="{D5CDD505-2E9C-101B-9397-08002B2CF9AE}" pid="3" name="ICV">
    <vt:lpwstr>37FB7BC4565A4C03A6884BF4635474C2_11</vt:lpwstr>
  </property>
</Properties>
</file>